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6" d="100"/>
          <a:sy n="56" d="100"/>
        </p:scale>
        <p:origin x="1336" y="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6/0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6/0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Forouhi</a:t>
            </a:r>
            <a:r>
              <a:rPr lang="en-GB" dirty="0"/>
              <a:t> (2023) Diabetologia DOI 10.1007/s00125-023-05873-z </a:t>
            </a:r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omplexity of diets and multiple influences affecting food intakes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6A68954-9ACE-C645-71C1-3760AAF0AF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80120" y="790810"/>
            <a:ext cx="6876256" cy="50864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0</cp:revision>
  <dcterms:created xsi:type="dcterms:W3CDTF">2016-06-15T12:53:43Z</dcterms:created>
  <dcterms:modified xsi:type="dcterms:W3CDTF">2023-02-06T11:43:46Z</dcterms:modified>
</cp:coreProperties>
</file>